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3" r:id="rId3"/>
    <p:sldId id="264" r:id="rId4"/>
    <p:sldId id="265" r:id="rId5"/>
    <p:sldId id="266" r:id="rId6"/>
    <p:sldId id="267" r:id="rId7"/>
    <p:sldId id="268" r:id="rId8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08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68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3712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6670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5505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3782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465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5672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3105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8226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712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8550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9304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55887" y="2821680"/>
            <a:ext cx="5915025" cy="6285266"/>
          </a:xfrm>
        </p:spPr>
        <p:txBody>
          <a:bodyPr/>
          <a:lstStyle/>
          <a:p>
            <a:endParaRPr kumimoji="1" lang="ja-JP" altLang="en-US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198" y="977146"/>
            <a:ext cx="6440200" cy="8639040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101030" y="792480"/>
            <a:ext cx="7979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ESAN1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90761" y="146149"/>
            <a:ext cx="633670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smtClean="0"/>
              <a:t>Fig </a:t>
            </a:r>
            <a:r>
              <a:rPr lang="en-US" altLang="ja-JP" sz="1400" dirty="0" smtClean="0"/>
              <a:t>S3 Prior </a:t>
            </a:r>
            <a:r>
              <a:rPr lang="en-US" altLang="ja-JP" sz="1400" dirty="0"/>
              <a:t>and posterior distributions for each </a:t>
            </a:r>
            <a:r>
              <a:rPr lang="en-US" altLang="ja-JP" sz="1400" dirty="0" smtClean="0"/>
              <a:t>parameter obtained </a:t>
            </a:r>
            <a:r>
              <a:rPr lang="en-US" altLang="ja-JP" sz="1400" dirty="0"/>
              <a:t>by DIYABC </a:t>
            </a:r>
            <a:r>
              <a:rPr lang="en-US" altLang="ja-JP" sz="1400" dirty="0" smtClean="0"/>
              <a:t>analysis for each population. X </a:t>
            </a:r>
            <a:r>
              <a:rPr lang="en-US" altLang="ja-JP" sz="1400" dirty="0"/>
              <a:t>axis indicate values for each title of </a:t>
            </a:r>
            <a:r>
              <a:rPr lang="en-US" altLang="ja-JP" sz="1400" dirty="0" smtClean="0"/>
              <a:t>graph. Y </a:t>
            </a:r>
            <a:r>
              <a:rPr kumimoji="1" lang="en-US" altLang="ja-JP" sz="1400" dirty="0" smtClean="0"/>
              <a:t>axis indicates probability of prior and posterior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122243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490" y="903923"/>
            <a:ext cx="6058851" cy="8564974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300490" y="160971"/>
            <a:ext cx="374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ESAN2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59574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kenkyuu\Desktop\SAND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625" y="957925"/>
            <a:ext cx="6051550" cy="81388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130596" y="177740"/>
            <a:ext cx="830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SAND1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04711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891" y="1126807"/>
            <a:ext cx="6249622" cy="8556308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00490" y="160971"/>
            <a:ext cx="374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KANT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88067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847" y="792481"/>
            <a:ext cx="6526311" cy="8998475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00490" y="160971"/>
            <a:ext cx="374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IZU1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2070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317" y="1139192"/>
            <a:ext cx="6301371" cy="8504575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00490" y="160971"/>
            <a:ext cx="374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IZU2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09159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kenkyuu\Desktop\g.SADO2png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214" y="1073152"/>
            <a:ext cx="6061219" cy="815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163512" y="104751"/>
            <a:ext cx="833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SADO1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3329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7</TotalTime>
  <Words>43</Words>
  <Application>Microsoft Office PowerPoint</Application>
  <PresentationFormat>A4 210 x 297 mm</PresentationFormat>
  <Paragraphs>8</Paragraphs>
  <Slides>7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8" baseType="lpstr"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 User</dc:creator>
  <cp:lastModifiedBy>Windows User</cp:lastModifiedBy>
  <cp:revision>23</cp:revision>
  <dcterms:created xsi:type="dcterms:W3CDTF">2016-02-26T00:50:55Z</dcterms:created>
  <dcterms:modified xsi:type="dcterms:W3CDTF">2016-06-07T09:35:00Z</dcterms:modified>
</cp:coreProperties>
</file>